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3" r:id="rId2"/>
    <p:sldId id="256" r:id="rId3"/>
    <p:sldId id="257" r:id="rId4"/>
    <p:sldId id="259" r:id="rId5"/>
    <p:sldId id="260" r:id="rId6"/>
    <p:sldId id="261" r:id="rId7"/>
    <p:sldId id="263" r:id="rId8"/>
    <p:sldId id="262" r:id="rId9"/>
    <p:sldId id="264" r:id="rId10"/>
    <p:sldId id="269" r:id="rId11"/>
    <p:sldId id="270" r:id="rId12"/>
    <p:sldId id="271" r:id="rId13"/>
    <p:sldId id="272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52"/>
    <p:restoredTop sz="94665"/>
  </p:normalViewPr>
  <p:slideViewPr>
    <p:cSldViewPr snapToGrid="0">
      <p:cViewPr varScale="1">
        <p:scale>
          <a:sx n="103" d="100"/>
          <a:sy n="103" d="100"/>
        </p:scale>
        <p:origin x="70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11808D-7AE9-38DF-F6E3-90627B7FB0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FEF91C-0EBF-F1F6-C4C9-F7003B7F3D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67B13-CFDD-585D-A985-3BDE11B19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4AB936-CA05-68F5-F8E9-9E1F71C57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EF1C97-8036-D84D-848E-127DB1854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852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A5DC11-A834-5939-D3F1-FF688B1DB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88CB41-4CD5-71EA-3841-5B8EC9105E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E8ECAB-4374-E373-54B5-6F8E1E7E9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8C8995-357E-4F60-25E6-38973F8AA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6224C4-62EE-0BC2-5B62-8AF152032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06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5D5CFD-B539-2BB5-F7BD-E39393BA86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723189-D1B2-05AF-A1A6-159792BCBB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3989D7-8C04-6AEC-8533-518BC5363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97DCB4-8EAD-E444-5C5E-55BB7A1CB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140F00-2950-0732-304B-281A4F723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166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E8ED7-AFD8-E44B-7F95-BAE4B1798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067A46-F52B-CB27-70DD-CE4BEFAC6A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4CBB5-E0C5-1CCF-9D58-DCBABA6EE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5CDB6-EDA5-C0C8-61BA-154A2C56A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85D713-E030-7FF9-61DF-2676A5364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968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4BCAD-7F88-B3BD-E318-A0CB023CAF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DB57C8-2988-684D-FFB3-54A2D64FC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B8F6A-AB54-E43D-31B3-9EF353AED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6692CD-DDF1-3A1C-3325-58D3FDEDC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9292A-B33A-E8A1-00AD-52CB90E93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565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D0566-5A6C-3983-26DB-7ACBBBA9A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1BAE7B-0AED-60A1-B99E-5D7356CDCD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593DC7-A63F-E421-4D24-FAD033879A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CE3999-E328-8FCD-6719-EC187750C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63BA1A-1B30-B484-39B4-A45BFB90B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136AB4-F4AC-3D63-79AC-D7E6235EB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101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674D9-45F2-59BB-B361-F406E498D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429C1C-7441-BF6F-D17E-01BA7037C1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621149-1D95-7C51-D37A-46952D92AF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CB7F3D-0AF6-FEF9-7BE6-3E51E66ED1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D933EDF-0EF6-12D3-EDAB-B7F092286A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3D52D2-763C-380A-1563-842A56C3C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25EEC0-A022-831C-C61F-FCD22710E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A516749-478A-66A2-F6ED-8F33D0190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732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C98ED4-AD1E-BFCD-901B-B363B0F15A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71A104-43B2-F92F-683A-ABBF63ACB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729FA9-0A98-EDFE-FB8F-5576340E0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F2E882-3A17-24B9-C553-AF13C5650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028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C958B4-2D59-55BA-C17C-B81FDEC6A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111A1C-58E7-48C0-EB3C-C4E4B5D5C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44CD45-95DB-832A-FA5B-722FE8E70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281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20BAB1-4038-D1EB-9EBC-AD6278B61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671B9B-9619-6AC5-FDF6-DFA1AC0821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54A51-6B4C-4BEF-DFA1-E0E6288FD0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CF21C8-15EF-0EEE-6380-7064DA442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C2820-2B7D-4ED9-8B3E-AA9B69B87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95E9A5-D230-E518-FE31-14DD89210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600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3DB575-CD7C-FB0E-8522-66698F8DD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AF76FE-1461-8DBF-06B3-8443A6D9A0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4E5DD9-8E50-939F-9B8C-8FD42177B4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D2B4B0-F7D8-B6CD-755F-38B00345C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C6AF8D-22CB-A8F6-7B3D-AE38007C9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189288-E287-1508-985A-AD1B6852A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918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98ED5D-A339-3496-E5CC-FEA0A1B3D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3C3876-C934-9265-6DC1-12C8FEE17F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1C3CDD-05C2-1889-51A1-F8F806FC42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8036C8-CEFE-BE76-E0C4-92CDB786DF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A35155-35DF-C296-3D9D-A0540B4563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360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A97C8F-5237-131D-995D-E476B7DECF57}"/>
              </a:ext>
            </a:extLst>
          </p:cNvPr>
          <p:cNvSpPr txBox="1"/>
          <p:nvPr/>
        </p:nvSpPr>
        <p:spPr>
          <a:xfrm>
            <a:off x="1753850" y="1304144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0578B5-E7DA-041A-D295-5E2C2CF8BD27}"/>
              </a:ext>
            </a:extLst>
          </p:cNvPr>
          <p:cNvSpPr txBox="1"/>
          <p:nvPr/>
        </p:nvSpPr>
        <p:spPr>
          <a:xfrm>
            <a:off x="4934263" y="1368888"/>
            <a:ext cx="1181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rp1(-/17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ACFB1C7-7BC8-C20E-65F3-E7B29AED66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8810" y="2120900"/>
            <a:ext cx="2540000" cy="2616200"/>
          </a:xfrm>
          <a:prstGeom prst="ellipse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3CECA36-EA07-6AD1-F863-7BB05632A0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3115" y="2120900"/>
            <a:ext cx="2641600" cy="2616200"/>
          </a:xfrm>
          <a:prstGeom prst="ellipse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BC7AAEC-47C1-37E3-4790-3F8FC0F3B3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29020" y="2120900"/>
            <a:ext cx="2692400" cy="2641600"/>
          </a:xfrm>
          <a:prstGeom prst="ellipse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5F84741-EC6A-5221-E183-A2E02DE2AFF7}"/>
              </a:ext>
            </a:extLst>
          </p:cNvPr>
          <p:cNvSpPr txBox="1"/>
          <p:nvPr/>
        </p:nvSpPr>
        <p:spPr>
          <a:xfrm>
            <a:off x="7979765" y="1368888"/>
            <a:ext cx="13452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rp1(16/17)</a:t>
            </a:r>
          </a:p>
        </p:txBody>
      </p:sp>
    </p:spTree>
    <p:extLst>
      <p:ext uri="{BB962C8B-B14F-4D97-AF65-F5344CB8AC3E}">
        <p14:creationId xmlns:p14="http://schemas.microsoft.com/office/powerpoint/2010/main" val="3577071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6F42E-BEDF-6988-1B0D-BF1648A30A8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2022.06.01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82C3E0-B524-685F-72CB-3AE27D41311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7 days-  Normal media</a:t>
            </a:r>
          </a:p>
        </p:txBody>
      </p:sp>
    </p:spTree>
    <p:extLst>
      <p:ext uri="{BB962C8B-B14F-4D97-AF65-F5344CB8AC3E}">
        <p14:creationId xmlns:p14="http://schemas.microsoft.com/office/powerpoint/2010/main" val="4104674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26430D02-632A-AF0D-B573-AF173CBF5EF5}"/>
              </a:ext>
            </a:extLst>
          </p:cNvPr>
          <p:cNvSpPr txBox="1">
            <a:spLocks/>
          </p:cNvSpPr>
          <p:nvPr/>
        </p:nvSpPr>
        <p:spPr>
          <a:xfrm>
            <a:off x="0" y="-2901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GFP-22.06.0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D02F31E-BD9A-E41D-17B5-DF3C9CDB593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856342"/>
            <a:ext cx="8839200" cy="58057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695815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26430D02-632A-AF0D-B573-AF173CBF5EF5}"/>
              </a:ext>
            </a:extLst>
          </p:cNvPr>
          <p:cNvSpPr txBox="1">
            <a:spLocks/>
          </p:cNvSpPr>
          <p:nvPr/>
        </p:nvSpPr>
        <p:spPr>
          <a:xfrm>
            <a:off x="0" y="-2901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Drp1(-/17)-22.06.0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851F946-DE50-F432-974A-E1B87A1F4F6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1035388"/>
            <a:ext cx="8839200" cy="5762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014826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26430D02-632A-AF0D-B573-AF173CBF5EF5}"/>
              </a:ext>
            </a:extLst>
          </p:cNvPr>
          <p:cNvSpPr txBox="1">
            <a:spLocks/>
          </p:cNvSpPr>
          <p:nvPr/>
        </p:nvSpPr>
        <p:spPr>
          <a:xfrm>
            <a:off x="0" y="-2901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/>
              <a:t>Drp1(16/17)-22.06.01</a:t>
            </a:r>
            <a:endParaRPr lang="en-US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5B34F58-C3EA-97F2-6FE3-BCB46423CA0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725714"/>
            <a:ext cx="8839200" cy="5849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4042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6F42E-BEDF-6988-1B0D-BF1648A30A8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2022.05.26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82C3E0-B524-685F-72CB-3AE27D41311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7 days-  Normal media</a:t>
            </a:r>
          </a:p>
        </p:txBody>
      </p:sp>
    </p:spTree>
    <p:extLst>
      <p:ext uri="{BB962C8B-B14F-4D97-AF65-F5344CB8AC3E}">
        <p14:creationId xmlns:p14="http://schemas.microsoft.com/office/powerpoint/2010/main" val="2250054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90175"/>
            <a:ext cx="10515600" cy="1325563"/>
          </a:xfrm>
        </p:spPr>
        <p:txBody>
          <a:bodyPr/>
          <a:lstStyle/>
          <a:p>
            <a:r>
              <a:rPr lang="en-US" dirty="0"/>
              <a:t>GFP-22.05.26</a:t>
            </a:r>
          </a:p>
        </p:txBody>
      </p:sp>
      <p:pic>
        <p:nvPicPr>
          <p:cNvPr id="5" name="Content Placeholder 4" descr="A picture containing indoor, wall, decorated&#10;&#10;Description automatically generated">
            <a:extLst>
              <a:ext uri="{FF2B5EF4-FFF2-40B4-BE49-F238E27FC236}">
                <a16:creationId xmlns:a16="http://schemas.microsoft.com/office/drawing/2014/main" id="{9CE2934C-C108-02A8-0DB8-F716730F1F0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5707" y="1035388"/>
            <a:ext cx="8530680" cy="5676172"/>
          </a:xfrm>
        </p:spPr>
      </p:pic>
    </p:spTree>
    <p:extLst>
      <p:ext uri="{BB962C8B-B14F-4D97-AF65-F5344CB8AC3E}">
        <p14:creationId xmlns:p14="http://schemas.microsoft.com/office/powerpoint/2010/main" val="19544939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80975"/>
            <a:ext cx="10515600" cy="1325563"/>
          </a:xfrm>
        </p:spPr>
        <p:txBody>
          <a:bodyPr/>
          <a:lstStyle/>
          <a:p>
            <a:r>
              <a:rPr lang="en-US" dirty="0"/>
              <a:t>Drp1(-/17)-22.05.26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39ABB-1983-BD81-CF24-26FB065D35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6C669D3-E59C-5106-0E6F-09242FC45B9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57" y="681037"/>
            <a:ext cx="8839200" cy="5977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30104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302532"/>
            <a:ext cx="10515600" cy="1325563"/>
          </a:xfrm>
        </p:spPr>
        <p:txBody>
          <a:bodyPr/>
          <a:lstStyle/>
          <a:p>
            <a:r>
              <a:rPr lang="en-US" dirty="0"/>
              <a:t>Drp1(16/17)-22.05.26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39ABB-1983-BD81-CF24-26FB065D35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C84088A-71C7-048E-5173-94AFDF422C4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7543" y="840693"/>
            <a:ext cx="8839200" cy="57923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25054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6F42E-BEDF-6988-1B0D-BF1648A30A8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2022.05.27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82C3E0-B524-685F-72CB-3AE27D41311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7 days-  Normal media</a:t>
            </a:r>
          </a:p>
        </p:txBody>
      </p:sp>
    </p:spTree>
    <p:extLst>
      <p:ext uri="{BB962C8B-B14F-4D97-AF65-F5344CB8AC3E}">
        <p14:creationId xmlns:p14="http://schemas.microsoft.com/office/powerpoint/2010/main" val="5790491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2E8819DB-009C-3FD4-E92D-335F6BE456BF}"/>
              </a:ext>
            </a:extLst>
          </p:cNvPr>
          <p:cNvSpPr txBox="1">
            <a:spLocks/>
          </p:cNvSpPr>
          <p:nvPr/>
        </p:nvSpPr>
        <p:spPr>
          <a:xfrm>
            <a:off x="0" y="-180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GFP-22.05.2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837B998-7F59-8B4F-68D1-63ED9F54469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1008742"/>
            <a:ext cx="8839200" cy="5849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06092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E1A7B9EF-FBDD-287D-E8F8-22B89979402F}"/>
              </a:ext>
            </a:extLst>
          </p:cNvPr>
          <p:cNvSpPr txBox="1">
            <a:spLocks/>
          </p:cNvSpPr>
          <p:nvPr/>
        </p:nvSpPr>
        <p:spPr>
          <a:xfrm>
            <a:off x="0" y="-2901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Drp1(-/17)-22.05.2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4753D58-152B-E539-41CC-9D112DD1293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8856" y="798285"/>
            <a:ext cx="8839200" cy="58057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46281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4C5E7753-E905-1BA3-FFD6-133A0607EE1F}"/>
              </a:ext>
            </a:extLst>
          </p:cNvPr>
          <p:cNvSpPr txBox="1">
            <a:spLocks/>
          </p:cNvSpPr>
          <p:nvPr/>
        </p:nvSpPr>
        <p:spPr>
          <a:xfrm>
            <a:off x="0" y="-1809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Drp1(16/17)-22.05.2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A0B969D-2F9D-4F54-F99C-FBFD3DC74FE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6914" y="1037771"/>
            <a:ext cx="8839200" cy="5820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2088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6</TotalTime>
  <Words>49</Words>
  <Application>Microsoft Macintosh PowerPoint</Application>
  <PresentationFormat>Widescreen</PresentationFormat>
  <Paragraphs>18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werPoint Presentation</vt:lpstr>
      <vt:lpstr>2022.05.26 </vt:lpstr>
      <vt:lpstr>GFP-22.05.26</vt:lpstr>
      <vt:lpstr>Drp1(-/17)-22.05.26</vt:lpstr>
      <vt:lpstr>Drp1(16/17)-22.05.26</vt:lpstr>
      <vt:lpstr>2022.05.27 </vt:lpstr>
      <vt:lpstr>PowerPoint Presentation</vt:lpstr>
      <vt:lpstr>PowerPoint Presentation</vt:lpstr>
      <vt:lpstr>PowerPoint Presentation</vt:lpstr>
      <vt:lpstr>2022.06.01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ved, Zaineb</dc:creator>
  <cp:lastModifiedBy>Zaineb Javed</cp:lastModifiedBy>
  <cp:revision>13</cp:revision>
  <dcterms:created xsi:type="dcterms:W3CDTF">2022-06-21T17:08:31Z</dcterms:created>
  <dcterms:modified xsi:type="dcterms:W3CDTF">2024-05-20T16:44:00Z</dcterms:modified>
</cp:coreProperties>
</file>